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AFDE74-3311-4EB5-815F-889DC9D8ED08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TW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0F999E-4F19-44E6-BAE0-EBC66FA14FD4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6D4E0-8C87-4EC9-958F-91BD89CD60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F2E95-CF0A-4B67-B171-AC1C52B0FB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3B1F3-8743-48B6-9808-960893A549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D62723-6E66-42F8-AED0-81A7AA318C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FBA03-A578-4856-BA7C-DA4BA9A58F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DF7E2E-6AAE-49A4-9DE8-52C7A457C1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D3ACD0-9E21-429F-8AB4-85E0916EE5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55A76-AE35-4301-813C-16BA839AC9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85A37-F827-410D-9B15-F6CFDACD4E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05B4AB-D5A1-4F31-99A7-FAE0315F96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7F03B1-7FE5-4E1D-8BA9-31F0E6D445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B2135-D601-46D1-B47D-0119F9850F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36C833-CE76-44CF-BF22-E4474D15DBC3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字方塊 2"/>
          <p:cNvSpPr/>
          <p:nvPr/>
        </p:nvSpPr>
        <p:spPr>
          <a:xfrm>
            <a:off x="4941720" y="7920"/>
            <a:ext cx="191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eh_Supplementary Fig. S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字方塊 7"/>
          <p:cNvSpPr/>
          <p:nvPr/>
        </p:nvSpPr>
        <p:spPr>
          <a:xfrm>
            <a:off x="2478240" y="2529000"/>
            <a:ext cx="63000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Cleave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PARP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34" descr="G:\20141024 scan整理\20141002 interferon attenuate mtx mediated parp1-cleavage-M-PARP1.tif"/>
          <p:cNvPicPr/>
          <p:nvPr/>
        </p:nvPicPr>
        <p:blipFill>
          <a:blip r:embed="rId1">
            <a:lum contrast="20000"/>
          </a:blip>
          <a:srcRect l="21474" t="7373" r="5502" b="22181"/>
          <a:stretch/>
        </p:blipFill>
        <p:spPr>
          <a:xfrm>
            <a:off x="1714680" y="2425680"/>
            <a:ext cx="792000" cy="289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1" name="Picture 35" descr="G:\20141024 scan整理\20141002 interferon attenuate mtx mediated parp1-cleavage-M-ACTIN.tif"/>
          <p:cNvPicPr/>
          <p:nvPr/>
        </p:nvPicPr>
        <p:blipFill>
          <a:blip r:embed="rId2">
            <a:lum bright="10000"/>
          </a:blip>
          <a:srcRect l="13144" t="15753" r="3232" b="23630"/>
          <a:stretch/>
        </p:blipFill>
        <p:spPr>
          <a:xfrm>
            <a:off x="1714680" y="2763720"/>
            <a:ext cx="792000" cy="179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2" name="文字方塊 8"/>
          <p:cNvSpPr/>
          <p:nvPr/>
        </p:nvSpPr>
        <p:spPr>
          <a:xfrm>
            <a:off x="2490840" y="1940040"/>
            <a:ext cx="417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字方塊 8"/>
          <p:cNvSpPr/>
          <p:nvPr/>
        </p:nvSpPr>
        <p:spPr>
          <a:xfrm>
            <a:off x="2486160" y="2195640"/>
            <a:ext cx="726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X (10 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字方塊 6"/>
          <p:cNvSpPr/>
          <p:nvPr/>
        </p:nvSpPr>
        <p:spPr>
          <a:xfrm>
            <a:off x="2471760" y="2754360"/>
            <a:ext cx="42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字方塊 7"/>
          <p:cNvSpPr/>
          <p:nvPr/>
        </p:nvSpPr>
        <p:spPr>
          <a:xfrm>
            <a:off x="2490840" y="2376360"/>
            <a:ext cx="60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PARP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字方塊 36"/>
          <p:cNvSpPr/>
          <p:nvPr/>
        </p:nvSpPr>
        <p:spPr>
          <a:xfrm>
            <a:off x="1308240" y="1619280"/>
            <a:ext cx="32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字方塊 59"/>
          <p:cNvSpPr/>
          <p:nvPr/>
        </p:nvSpPr>
        <p:spPr>
          <a:xfrm>
            <a:off x="1887480" y="217800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字方塊 59"/>
          <p:cNvSpPr/>
          <p:nvPr/>
        </p:nvSpPr>
        <p:spPr>
          <a:xfrm>
            <a:off x="2076480" y="217800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直線接點 104"/>
          <p:cNvSpPr/>
          <p:nvPr/>
        </p:nvSpPr>
        <p:spPr>
          <a:xfrm>
            <a:off x="1793880" y="231624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字方塊 59"/>
          <p:cNvSpPr/>
          <p:nvPr/>
        </p:nvSpPr>
        <p:spPr>
          <a:xfrm>
            <a:off x="2244600" y="217800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7" descr="G:\20141227-invasion assay\20141120-pc0035.tif"/>
          <p:cNvPicPr/>
          <p:nvPr/>
        </p:nvPicPr>
        <p:blipFill>
          <a:blip r:embed="rId3">
            <a:grayscl/>
          </a:blip>
          <a:stretch/>
        </p:blipFill>
        <p:spPr>
          <a:xfrm>
            <a:off x="3357720" y="1555920"/>
            <a:ext cx="766440" cy="6109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2" name="Picture 8" descr="G:\20141227-invasion assay\20141120-pc0043.tif"/>
          <p:cNvPicPr/>
          <p:nvPr/>
        </p:nvPicPr>
        <p:blipFill>
          <a:blip r:embed="rId4">
            <a:grayscl/>
          </a:blip>
          <a:stretch/>
        </p:blipFill>
        <p:spPr>
          <a:xfrm>
            <a:off x="4164120" y="1554120"/>
            <a:ext cx="765000" cy="611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3" name="Picture 14" descr="G:\20141227-invasion assay\20141120-pc0050.tif"/>
          <p:cNvPicPr/>
          <p:nvPr/>
        </p:nvPicPr>
        <p:blipFill>
          <a:blip r:embed="rId5">
            <a:grayscl/>
          </a:blip>
          <a:stretch/>
        </p:blipFill>
        <p:spPr>
          <a:xfrm>
            <a:off x="3357720" y="2340000"/>
            <a:ext cx="766440" cy="611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4" name="Picture 3" descr="G:\20141227-invasion assay\20141120-pc0056.tif"/>
          <p:cNvPicPr/>
          <p:nvPr/>
        </p:nvPicPr>
        <p:blipFill>
          <a:blip r:embed="rId6">
            <a:grayscl/>
          </a:blip>
          <a:stretch/>
        </p:blipFill>
        <p:spPr>
          <a:xfrm>
            <a:off x="4164120" y="2340000"/>
            <a:ext cx="766800" cy="611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5" name="文字方塊 84"/>
          <p:cNvSpPr/>
          <p:nvPr/>
        </p:nvSpPr>
        <p:spPr>
          <a:xfrm>
            <a:off x="3500280" y="1393920"/>
            <a:ext cx="516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Vehicl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字方塊 86"/>
          <p:cNvSpPr/>
          <p:nvPr/>
        </p:nvSpPr>
        <p:spPr>
          <a:xfrm>
            <a:off x="4324320" y="1393920"/>
            <a:ext cx="450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600" spc="-1" strike="noStrike">
                <a:solidFill>
                  <a:srgbClr val="000000"/>
                </a:solidFill>
                <a:latin typeface="Symbol"/>
                <a:ea typeface="Symbol"/>
              </a:rPr>
              <a:t>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字方塊 86"/>
          <p:cNvSpPr/>
          <p:nvPr/>
        </p:nvSpPr>
        <p:spPr>
          <a:xfrm>
            <a:off x="3500280" y="2184480"/>
            <a:ext cx="596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600" spc="-1" strike="noStrike">
                <a:solidFill>
                  <a:srgbClr val="000000"/>
                </a:solidFill>
                <a:latin typeface="Symbol"/>
                <a:ea typeface="Symbol"/>
              </a:rPr>
              <a:t></a:t>
            </a: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Y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字方塊 86"/>
          <p:cNvSpPr/>
          <p:nvPr/>
        </p:nvSpPr>
        <p:spPr>
          <a:xfrm>
            <a:off x="4316400" y="2184480"/>
            <a:ext cx="704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600" spc="-1" strike="noStrike">
                <a:solidFill>
                  <a:srgbClr val="000000"/>
                </a:solidFill>
                <a:latin typeface="Symbol"/>
                <a:ea typeface="Symbol"/>
              </a:rPr>
              <a:t></a:t>
            </a: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SB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直線接點 44"/>
          <p:cNvSpPr/>
          <p:nvPr/>
        </p:nvSpPr>
        <p:spPr>
          <a:xfrm>
            <a:off x="4775040" y="3121200"/>
            <a:ext cx="16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字方塊 45"/>
          <p:cNvSpPr/>
          <p:nvPr/>
        </p:nvSpPr>
        <p:spPr>
          <a:xfrm>
            <a:off x="4629240" y="2957400"/>
            <a:ext cx="5554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00 </a:t>
            </a:r>
            <a:r>
              <a:rPr b="0" lang="en-US" sz="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字方塊 5"/>
          <p:cNvSpPr/>
          <p:nvPr/>
        </p:nvSpPr>
        <p:spPr>
          <a:xfrm rot="16200000">
            <a:off x="1982520" y="2006280"/>
            <a:ext cx="42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5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字方塊 53"/>
          <p:cNvSpPr/>
          <p:nvPr/>
        </p:nvSpPr>
        <p:spPr>
          <a:xfrm rot="16200000">
            <a:off x="2147760" y="2006280"/>
            <a:ext cx="42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10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文字方塊 5"/>
          <p:cNvSpPr/>
          <p:nvPr/>
        </p:nvSpPr>
        <p:spPr>
          <a:xfrm rot="16200000">
            <a:off x="1695240" y="2079360"/>
            <a:ext cx="28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文字方塊 5"/>
          <p:cNvSpPr/>
          <p:nvPr/>
        </p:nvSpPr>
        <p:spPr>
          <a:xfrm rot="16200000">
            <a:off x="1863720" y="2079360"/>
            <a:ext cx="28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文字方塊 29"/>
          <p:cNvSpPr/>
          <p:nvPr/>
        </p:nvSpPr>
        <p:spPr>
          <a:xfrm>
            <a:off x="2476440" y="2054160"/>
            <a:ext cx="66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(units/ml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文字方塊 36"/>
          <p:cNvSpPr/>
          <p:nvPr/>
        </p:nvSpPr>
        <p:spPr>
          <a:xfrm>
            <a:off x="3178080" y="1116000"/>
            <a:ext cx="32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8T07:00:22Z</dcterms:created>
  <dc:creator>yeh</dc:creator>
  <dc:description/>
  <dc:language>en-US</dc:language>
  <cp:lastModifiedBy>Abella, Jerard Dave</cp:lastModifiedBy>
  <dcterms:modified xsi:type="dcterms:W3CDTF">2018-03-13T10:52:14Z</dcterms:modified>
  <cp:revision>24</cp:revision>
  <dc:subject/>
  <dc:title>PowerPoint 簡報</dc:title>
</cp:coreProperties>
</file>